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75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199" autoAdjust="0"/>
    <p:restoredTop sz="93100" autoAdjust="0"/>
  </p:normalViewPr>
  <p:slideViewPr>
    <p:cSldViewPr snapToGrid="0">
      <p:cViewPr varScale="1">
        <p:scale>
          <a:sx n="49" d="100"/>
          <a:sy n="49" d="100"/>
        </p:scale>
        <p:origin x="91" y="658"/>
      </p:cViewPr>
      <p:guideLst/>
    </p:cSldViewPr>
  </p:slid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omo\Dropbox\&#21307;&#23398;\&#30740;&#31350;\%5bFEM%20&#25163;&#38306;&#31680;&#32930;&#20301;&#12391;&#12398;&#38306;&#31680;&#38754;&#22311;&#20998;&#24067;%5d\%5b&#12487;&#12540;&#12479;%5d\&#27208;&#39592;&#38306;&#31680;&#38754;2&#20998;&#21106;%20&#27208;&#23610;&#23624;%20&#9733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omo\Dropbox\&#21307;&#23398;\&#30740;&#31350;\%5bFEM%20&#25163;&#38306;&#31680;&#32930;&#20301;&#12391;&#12398;&#38306;&#31680;&#38754;&#22311;&#20998;&#24067;%5d\%5b&#12487;&#12540;&#12479;%5d\&#27208;&#39592;&#38306;&#31680;&#38754;2&#20998;&#21106;%20&#27208;&#23610;&#23624;%20&#9733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08739951754142"/>
          <c:y val="2.5067400230663429E-2"/>
          <c:w val="0.86767747068752299"/>
          <c:h val="0.7619362582604252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角度内%'!$L$4</c:f>
              <c:strCache>
                <c:ptCount val="1"/>
                <c:pt idx="0">
                  <c:v>Lunate fossa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角度内%'!$M$12:$T$12</c:f>
                <c:numCache>
                  <c:formatCode>General</c:formatCode>
                  <c:ptCount val="8"/>
                  <c:pt idx="0">
                    <c:v>3.7376475005224914</c:v>
                  </c:pt>
                  <c:pt idx="1">
                    <c:v>3.8967609223745554</c:v>
                  </c:pt>
                  <c:pt idx="2">
                    <c:v>3.4210812834389226</c:v>
                  </c:pt>
                  <c:pt idx="3">
                    <c:v>2.5687929198833301</c:v>
                  </c:pt>
                  <c:pt idx="4">
                    <c:v>2.2297634631541796</c:v>
                  </c:pt>
                  <c:pt idx="5">
                    <c:v>1.9898358006347967</c:v>
                  </c:pt>
                  <c:pt idx="6">
                    <c:v>2.6994220130466275</c:v>
                  </c:pt>
                  <c:pt idx="7">
                    <c:v>4.0411855202010596</c:v>
                  </c:pt>
                </c:numCache>
              </c:numRef>
            </c:plus>
            <c:minus>
              <c:numRef>
                <c:f>'角度内%'!$M$12:$T$12</c:f>
                <c:numCache>
                  <c:formatCode>General</c:formatCode>
                  <c:ptCount val="8"/>
                  <c:pt idx="0">
                    <c:v>3.7376475005224914</c:v>
                  </c:pt>
                  <c:pt idx="1">
                    <c:v>3.8967609223745554</c:v>
                  </c:pt>
                  <c:pt idx="2">
                    <c:v>3.4210812834389226</c:v>
                  </c:pt>
                  <c:pt idx="3">
                    <c:v>2.5687929198833301</c:v>
                  </c:pt>
                  <c:pt idx="4">
                    <c:v>2.2297634631541796</c:v>
                  </c:pt>
                  <c:pt idx="5">
                    <c:v>1.9898358006347967</c:v>
                  </c:pt>
                  <c:pt idx="6">
                    <c:v>2.6994220130466275</c:v>
                  </c:pt>
                  <c:pt idx="7">
                    <c:v>4.04118552020105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角度内%'!$M$3:$T$3</c:f>
              <c:strCache>
                <c:ptCount val="8"/>
                <c:pt idx="0">
                  <c:v>RD15</c:v>
                </c:pt>
                <c:pt idx="1">
                  <c:v>RD10</c:v>
                </c:pt>
                <c:pt idx="2">
                  <c:v>RD5</c:v>
                </c:pt>
                <c:pt idx="3">
                  <c:v>Neutral</c:v>
                </c:pt>
                <c:pt idx="4">
                  <c:v>UD5</c:v>
                </c:pt>
                <c:pt idx="5">
                  <c:v>UD10</c:v>
                </c:pt>
                <c:pt idx="6">
                  <c:v>UD15</c:v>
                </c:pt>
                <c:pt idx="7">
                  <c:v>UD20</c:v>
                </c:pt>
              </c:strCache>
            </c:strRef>
          </c:cat>
          <c:val>
            <c:numRef>
              <c:f>'角度内%'!$M$4:$T$4</c:f>
              <c:numCache>
                <c:formatCode>General</c:formatCode>
                <c:ptCount val="8"/>
                <c:pt idx="0">
                  <c:v>31.984143555258903</c:v>
                </c:pt>
                <c:pt idx="1">
                  <c:v>33.023942233151402</c:v>
                </c:pt>
                <c:pt idx="2">
                  <c:v>34.102841915220651</c:v>
                </c:pt>
                <c:pt idx="3">
                  <c:v>35.96746270774657</c:v>
                </c:pt>
                <c:pt idx="4">
                  <c:v>37.381796624426684</c:v>
                </c:pt>
                <c:pt idx="5">
                  <c:v>38.485164233993473</c:v>
                </c:pt>
                <c:pt idx="6">
                  <c:v>38.524206939328707</c:v>
                </c:pt>
                <c:pt idx="7">
                  <c:v>35.9695719784043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639-47BF-B47B-AA6EF99B24B3}"/>
            </c:ext>
          </c:extLst>
        </c:ser>
        <c:ser>
          <c:idx val="1"/>
          <c:order val="1"/>
          <c:tx>
            <c:strRef>
              <c:f>'角度内%'!$L$5</c:f>
              <c:strCache>
                <c:ptCount val="1"/>
                <c:pt idx="0">
                  <c:v>Scaphoid fossa</c:v>
                </c:pt>
              </c:strCache>
            </c:strRef>
          </c:tx>
          <c:spPr>
            <a:solidFill>
              <a:srgbClr val="92D05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角度内%'!$M$12:$T$12</c:f>
                <c:numCache>
                  <c:formatCode>General</c:formatCode>
                  <c:ptCount val="8"/>
                  <c:pt idx="0">
                    <c:v>3.7376475005224914</c:v>
                  </c:pt>
                  <c:pt idx="1">
                    <c:v>3.8967609223745554</c:v>
                  </c:pt>
                  <c:pt idx="2">
                    <c:v>3.4210812834389226</c:v>
                  </c:pt>
                  <c:pt idx="3">
                    <c:v>2.5687929198833301</c:v>
                  </c:pt>
                  <c:pt idx="4">
                    <c:v>2.2297634631541796</c:v>
                  </c:pt>
                  <c:pt idx="5">
                    <c:v>1.9898358006347967</c:v>
                  </c:pt>
                  <c:pt idx="6">
                    <c:v>2.6994220130466275</c:v>
                  </c:pt>
                  <c:pt idx="7">
                    <c:v>4.0411855202010596</c:v>
                  </c:pt>
                </c:numCache>
              </c:numRef>
            </c:plus>
            <c:minus>
              <c:numRef>
                <c:f>'角度内%'!$M$13:$T$13</c:f>
                <c:numCache>
                  <c:formatCode>General</c:formatCode>
                  <c:ptCount val="8"/>
                  <c:pt idx="0">
                    <c:v>3.7376475005224914</c:v>
                  </c:pt>
                  <c:pt idx="1">
                    <c:v>3.8967609223745554</c:v>
                  </c:pt>
                  <c:pt idx="2">
                    <c:v>3.4210812834389226</c:v>
                  </c:pt>
                  <c:pt idx="3">
                    <c:v>2.5687929198833301</c:v>
                  </c:pt>
                  <c:pt idx="4">
                    <c:v>2.2297634631541796</c:v>
                  </c:pt>
                  <c:pt idx="5">
                    <c:v>1.9898358006347967</c:v>
                  </c:pt>
                  <c:pt idx="6">
                    <c:v>2.6994220130466275</c:v>
                  </c:pt>
                  <c:pt idx="7">
                    <c:v>4.04118552020105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角度内%'!$M$3:$T$3</c:f>
              <c:strCache>
                <c:ptCount val="8"/>
                <c:pt idx="0">
                  <c:v>RD15</c:v>
                </c:pt>
                <c:pt idx="1">
                  <c:v>RD10</c:v>
                </c:pt>
                <c:pt idx="2">
                  <c:v>RD5</c:v>
                </c:pt>
                <c:pt idx="3">
                  <c:v>Neutral</c:v>
                </c:pt>
                <c:pt idx="4">
                  <c:v>UD5</c:v>
                </c:pt>
                <c:pt idx="5">
                  <c:v>UD10</c:v>
                </c:pt>
                <c:pt idx="6">
                  <c:v>UD15</c:v>
                </c:pt>
                <c:pt idx="7">
                  <c:v>UD20</c:v>
                </c:pt>
              </c:strCache>
            </c:strRef>
          </c:cat>
          <c:val>
            <c:numRef>
              <c:f>'角度内%'!$M$5:$T$5</c:f>
              <c:numCache>
                <c:formatCode>General</c:formatCode>
                <c:ptCount val="8"/>
                <c:pt idx="0">
                  <c:v>68.015856444741075</c:v>
                </c:pt>
                <c:pt idx="1">
                  <c:v>66.976057766848598</c:v>
                </c:pt>
                <c:pt idx="2">
                  <c:v>65.897158084779349</c:v>
                </c:pt>
                <c:pt idx="3">
                  <c:v>64.032537292253437</c:v>
                </c:pt>
                <c:pt idx="4">
                  <c:v>62.618203375573316</c:v>
                </c:pt>
                <c:pt idx="5">
                  <c:v>61.514835766006527</c:v>
                </c:pt>
                <c:pt idx="6">
                  <c:v>61.475793060671293</c:v>
                </c:pt>
                <c:pt idx="7">
                  <c:v>64.0304280215956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639-47BF-B47B-AA6EF99B24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03589343"/>
        <c:axId val="118598127"/>
      </c:barChart>
      <c:catAx>
        <c:axId val="21035893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18598127"/>
        <c:crosses val="autoZero"/>
        <c:auto val="1"/>
        <c:lblAlgn val="ctr"/>
        <c:lblOffset val="100"/>
        <c:noMultiLvlLbl val="0"/>
      </c:catAx>
      <c:valAx>
        <c:axId val="118598127"/>
        <c:scaling>
          <c:orientation val="minMax"/>
          <c:max val="8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kumimoji="1" lang="en-US" altLang="ja-JP" sz="1400" b="0" i="0" u="none" strike="noStrike" kern="1200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quivalent </a:t>
                </a:r>
                <a:r>
                  <a:rPr lang="en-US" dirty="0"/>
                  <a:t>Stress (%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1.6153206360769824E-2"/>
              <c:y val="0.131972906456665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103589343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6.3757612664532184E-2"/>
          <c:y val="0.89963414909122863"/>
          <c:w val="0.93624241900122196"/>
          <c:h val="9.388547941151674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08739951754142"/>
          <c:y val="2.5067400230663429E-2"/>
          <c:w val="0.86767747068752299"/>
          <c:h val="0.765876257348330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角度内%'!$AG$4</c:f>
              <c:strCache>
                <c:ptCount val="1"/>
                <c:pt idx="0">
                  <c:v>Volar aspect</c:v>
                </c:pt>
              </c:strCache>
            </c:strRef>
          </c:tx>
          <c:spPr>
            <a:solidFill>
              <a:srgbClr val="FFFF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角度内%'!$AH$12:$AO$12</c:f>
                <c:numCache>
                  <c:formatCode>General</c:formatCode>
                  <c:ptCount val="8"/>
                  <c:pt idx="0">
                    <c:v>4.8572700163471509</c:v>
                  </c:pt>
                  <c:pt idx="1">
                    <c:v>4.6449992077572153</c:v>
                  </c:pt>
                  <c:pt idx="2">
                    <c:v>5.1616557470089388</c:v>
                  </c:pt>
                  <c:pt idx="3">
                    <c:v>4.2078537872697916</c:v>
                  </c:pt>
                  <c:pt idx="4">
                    <c:v>5.8198203892193998</c:v>
                  </c:pt>
                  <c:pt idx="5">
                    <c:v>5.501900996809872</c:v>
                  </c:pt>
                  <c:pt idx="6">
                    <c:v>6.1105616612440325</c:v>
                  </c:pt>
                  <c:pt idx="7">
                    <c:v>5.1886137356963271</c:v>
                  </c:pt>
                </c:numCache>
              </c:numRef>
            </c:plus>
            <c:minus>
              <c:numRef>
                <c:f>'角度内%'!$AH$12:$AO$12</c:f>
                <c:numCache>
                  <c:formatCode>General</c:formatCode>
                  <c:ptCount val="8"/>
                  <c:pt idx="0">
                    <c:v>4.8572700163471509</c:v>
                  </c:pt>
                  <c:pt idx="1">
                    <c:v>4.6449992077572153</c:v>
                  </c:pt>
                  <c:pt idx="2">
                    <c:v>5.1616557470089388</c:v>
                  </c:pt>
                  <c:pt idx="3">
                    <c:v>4.2078537872697916</c:v>
                  </c:pt>
                  <c:pt idx="4">
                    <c:v>5.8198203892193998</c:v>
                  </c:pt>
                  <c:pt idx="5">
                    <c:v>5.501900996809872</c:v>
                  </c:pt>
                  <c:pt idx="6">
                    <c:v>6.1105616612440325</c:v>
                  </c:pt>
                  <c:pt idx="7">
                    <c:v>5.18861373569632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角度内%'!$AH$3:$AO$3</c:f>
              <c:strCache>
                <c:ptCount val="8"/>
                <c:pt idx="0">
                  <c:v>RD15</c:v>
                </c:pt>
                <c:pt idx="1">
                  <c:v>RD10</c:v>
                </c:pt>
                <c:pt idx="2">
                  <c:v>RD5</c:v>
                </c:pt>
                <c:pt idx="3">
                  <c:v>Neutral</c:v>
                </c:pt>
                <c:pt idx="4">
                  <c:v>UD5</c:v>
                </c:pt>
                <c:pt idx="5">
                  <c:v>UD10</c:v>
                </c:pt>
                <c:pt idx="6">
                  <c:v>UD15</c:v>
                </c:pt>
                <c:pt idx="7">
                  <c:v>UD20</c:v>
                </c:pt>
              </c:strCache>
            </c:strRef>
          </c:cat>
          <c:val>
            <c:numRef>
              <c:f>'角度内%'!$AH$4:$AO$4</c:f>
              <c:numCache>
                <c:formatCode>General</c:formatCode>
                <c:ptCount val="8"/>
                <c:pt idx="0">
                  <c:v>52.085108423901289</c:v>
                </c:pt>
                <c:pt idx="1">
                  <c:v>49.964299649608037</c:v>
                </c:pt>
                <c:pt idx="2">
                  <c:v>49.731960855529465</c:v>
                </c:pt>
                <c:pt idx="3">
                  <c:v>52.307182247649067</c:v>
                </c:pt>
                <c:pt idx="4">
                  <c:v>50.820604306338858</c:v>
                </c:pt>
                <c:pt idx="5">
                  <c:v>50.158204837013812</c:v>
                </c:pt>
                <c:pt idx="6">
                  <c:v>49.921458370508624</c:v>
                </c:pt>
                <c:pt idx="7">
                  <c:v>50.006328866261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694-4472-935B-36623200590A}"/>
            </c:ext>
          </c:extLst>
        </c:ser>
        <c:ser>
          <c:idx val="1"/>
          <c:order val="1"/>
          <c:tx>
            <c:strRef>
              <c:f>'角度内%'!$AG$5</c:f>
              <c:strCache>
                <c:ptCount val="1"/>
                <c:pt idx="0">
                  <c:v>Dorsal aspect</c:v>
                </c:pt>
              </c:strCache>
            </c:strRef>
          </c:tx>
          <c:spPr>
            <a:solidFill>
              <a:srgbClr val="FF3399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角度内%'!$AH$13:$AO$13</c:f>
                <c:numCache>
                  <c:formatCode>General</c:formatCode>
                  <c:ptCount val="8"/>
                  <c:pt idx="0">
                    <c:v>4.8572700163471509</c:v>
                  </c:pt>
                  <c:pt idx="1">
                    <c:v>4.6449992077572153</c:v>
                  </c:pt>
                  <c:pt idx="2">
                    <c:v>5.1616557470089388</c:v>
                  </c:pt>
                  <c:pt idx="3">
                    <c:v>4.2078537872697916</c:v>
                  </c:pt>
                  <c:pt idx="4">
                    <c:v>5.8198203892193998</c:v>
                  </c:pt>
                  <c:pt idx="5">
                    <c:v>5.501900996809872</c:v>
                  </c:pt>
                  <c:pt idx="6">
                    <c:v>6.1105616612440325</c:v>
                  </c:pt>
                  <c:pt idx="7">
                    <c:v>5.1886137356963271</c:v>
                  </c:pt>
                </c:numCache>
              </c:numRef>
            </c:plus>
            <c:minus>
              <c:numRef>
                <c:f>'角度内%'!$AH$13:$AO$13</c:f>
                <c:numCache>
                  <c:formatCode>General</c:formatCode>
                  <c:ptCount val="8"/>
                  <c:pt idx="0">
                    <c:v>4.8572700163471509</c:v>
                  </c:pt>
                  <c:pt idx="1">
                    <c:v>4.6449992077572153</c:v>
                  </c:pt>
                  <c:pt idx="2">
                    <c:v>5.1616557470089388</c:v>
                  </c:pt>
                  <c:pt idx="3">
                    <c:v>4.2078537872697916</c:v>
                  </c:pt>
                  <c:pt idx="4">
                    <c:v>5.8198203892193998</c:v>
                  </c:pt>
                  <c:pt idx="5">
                    <c:v>5.501900996809872</c:v>
                  </c:pt>
                  <c:pt idx="6">
                    <c:v>6.1105616612440325</c:v>
                  </c:pt>
                  <c:pt idx="7">
                    <c:v>5.18861373569632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角度内%'!$AH$3:$AO$3</c:f>
              <c:strCache>
                <c:ptCount val="8"/>
                <c:pt idx="0">
                  <c:v>RD15</c:v>
                </c:pt>
                <c:pt idx="1">
                  <c:v>RD10</c:v>
                </c:pt>
                <c:pt idx="2">
                  <c:v>RD5</c:v>
                </c:pt>
                <c:pt idx="3">
                  <c:v>Neutral</c:v>
                </c:pt>
                <c:pt idx="4">
                  <c:v>UD5</c:v>
                </c:pt>
                <c:pt idx="5">
                  <c:v>UD10</c:v>
                </c:pt>
                <c:pt idx="6">
                  <c:v>UD15</c:v>
                </c:pt>
                <c:pt idx="7">
                  <c:v>UD20</c:v>
                </c:pt>
              </c:strCache>
            </c:strRef>
          </c:cat>
          <c:val>
            <c:numRef>
              <c:f>'角度内%'!$AH$5:$AO$5</c:f>
              <c:numCache>
                <c:formatCode>General</c:formatCode>
                <c:ptCount val="8"/>
                <c:pt idx="0">
                  <c:v>47.914891576098704</c:v>
                </c:pt>
                <c:pt idx="1">
                  <c:v>50.035700350391963</c:v>
                </c:pt>
                <c:pt idx="2">
                  <c:v>50.268039144470535</c:v>
                </c:pt>
                <c:pt idx="3">
                  <c:v>47.692817752350933</c:v>
                </c:pt>
                <c:pt idx="4">
                  <c:v>49.179395693661135</c:v>
                </c:pt>
                <c:pt idx="5">
                  <c:v>49.841795162986195</c:v>
                </c:pt>
                <c:pt idx="6">
                  <c:v>50.078541629491383</c:v>
                </c:pt>
                <c:pt idx="7">
                  <c:v>49.9936711337383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694-4472-935B-3662320059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03589343"/>
        <c:axId val="118598127"/>
      </c:barChart>
      <c:catAx>
        <c:axId val="21035893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18598127"/>
        <c:crosses val="autoZero"/>
        <c:auto val="1"/>
        <c:lblAlgn val="ctr"/>
        <c:lblOffset val="100"/>
        <c:noMultiLvlLbl val="0"/>
      </c:catAx>
      <c:valAx>
        <c:axId val="118598127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kumimoji="1" lang="en-US" altLang="ja-JP" sz="1400" b="0" i="0" u="none" strike="noStrike" kern="1200" baseline="0" dirty="0">
                    <a:solidFill>
                      <a:prstClr val="black">
                        <a:lumMod val="65000"/>
                        <a:lumOff val="35000"/>
                      </a:prst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quivalent </a:t>
                </a:r>
                <a:r>
                  <a:rPr lang="en-US" dirty="0"/>
                  <a:t>Stress (%)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2.2046494686069805E-2"/>
              <c:y val="0.1559147607567404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low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2103589343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6917920487859331"/>
          <c:y val="0.91053596086805311"/>
          <c:w val="0.53894203128328078"/>
          <c:h val="8.859015599273074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4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776E5F-83B1-4EFB-BAC8-7C5B8C2156D6}" type="datetimeFigureOut">
              <a:rPr kumimoji="1" lang="ja-JP" altLang="en-US" smtClean="0"/>
              <a:t>2024/11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7BA3CA-BD4A-4096-9224-00AEEFE7D2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13984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02CC7-555F-4B73-AD51-0B48EDD14876}" type="datetimeFigureOut">
              <a:rPr kumimoji="1" lang="ja-JP" altLang="en-US" smtClean="0"/>
              <a:t>2024/1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A16FA-330E-46A5-A3D4-5AC980C14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87509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02CC7-555F-4B73-AD51-0B48EDD14876}" type="datetimeFigureOut">
              <a:rPr kumimoji="1" lang="ja-JP" altLang="en-US" smtClean="0"/>
              <a:t>2024/1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A16FA-330E-46A5-A3D4-5AC980C14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7364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02CC7-555F-4B73-AD51-0B48EDD14876}" type="datetimeFigureOut">
              <a:rPr kumimoji="1" lang="ja-JP" altLang="en-US" smtClean="0"/>
              <a:t>2024/1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A16FA-330E-46A5-A3D4-5AC980C14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1276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02CC7-555F-4B73-AD51-0B48EDD14876}" type="datetimeFigureOut">
              <a:rPr kumimoji="1" lang="ja-JP" altLang="en-US" smtClean="0"/>
              <a:t>2024/1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A16FA-330E-46A5-A3D4-5AC980C14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2445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02CC7-555F-4B73-AD51-0B48EDD14876}" type="datetimeFigureOut">
              <a:rPr kumimoji="1" lang="ja-JP" altLang="en-US" smtClean="0"/>
              <a:t>2024/1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A16FA-330E-46A5-A3D4-5AC980C14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4605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02CC7-555F-4B73-AD51-0B48EDD14876}" type="datetimeFigureOut">
              <a:rPr kumimoji="1" lang="ja-JP" altLang="en-US" smtClean="0"/>
              <a:t>2024/1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A16FA-330E-46A5-A3D4-5AC980C14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7825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02CC7-555F-4B73-AD51-0B48EDD14876}" type="datetimeFigureOut">
              <a:rPr kumimoji="1" lang="ja-JP" altLang="en-US" smtClean="0"/>
              <a:t>2024/11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A16FA-330E-46A5-A3D4-5AC980C14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0289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02CC7-555F-4B73-AD51-0B48EDD14876}" type="datetimeFigureOut">
              <a:rPr kumimoji="1" lang="ja-JP" altLang="en-US" smtClean="0"/>
              <a:t>2024/11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A16FA-330E-46A5-A3D4-5AC980C14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39725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02CC7-555F-4B73-AD51-0B48EDD14876}" type="datetimeFigureOut">
              <a:rPr kumimoji="1" lang="ja-JP" altLang="en-US" smtClean="0"/>
              <a:t>2024/11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A16FA-330E-46A5-A3D4-5AC980C14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6083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02CC7-555F-4B73-AD51-0B48EDD14876}" type="datetimeFigureOut">
              <a:rPr kumimoji="1" lang="ja-JP" altLang="en-US" smtClean="0"/>
              <a:t>2024/1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A16FA-330E-46A5-A3D4-5AC980C14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1108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B02CC7-555F-4B73-AD51-0B48EDD14876}" type="datetimeFigureOut">
              <a:rPr kumimoji="1" lang="ja-JP" altLang="en-US" smtClean="0"/>
              <a:t>2024/1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4A16FA-330E-46A5-A3D4-5AC980C14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48293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B02CC7-555F-4B73-AD51-0B48EDD14876}" type="datetimeFigureOut">
              <a:rPr kumimoji="1" lang="ja-JP" altLang="en-US" smtClean="0"/>
              <a:t>2024/1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4A16FA-330E-46A5-A3D4-5AC980C147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48898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F3AC9F94-28B5-4DB7-BDEA-AD13C7A0EBA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80533639"/>
              </p:ext>
            </p:extLst>
          </p:nvPr>
        </p:nvGraphicFramePr>
        <p:xfrm>
          <a:off x="0" y="1817324"/>
          <a:ext cx="5957455" cy="32233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9BE2A8F7-315A-4AA9-A3E4-2EC557E18F7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1204431"/>
              </p:ext>
            </p:extLst>
          </p:nvPr>
        </p:nvGraphicFramePr>
        <p:xfrm>
          <a:off x="6171965" y="1817324"/>
          <a:ext cx="5957455" cy="32233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8D565FD-BA2E-9067-6BD4-26496DB860C7}"/>
              </a:ext>
            </a:extLst>
          </p:cNvPr>
          <p:cNvSpPr txBox="1"/>
          <p:nvPr/>
        </p:nvSpPr>
        <p:spPr>
          <a:xfrm>
            <a:off x="88177" y="4598126"/>
            <a:ext cx="3226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游明朝 Light" panose="02020300000000000000" pitchFamily="18" charset="-128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ea typeface="游明朝 Light" panose="020203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9450D68-D2C0-B9A1-C494-B932D81DC529}"/>
              </a:ext>
            </a:extLst>
          </p:cNvPr>
          <p:cNvSpPr txBox="1"/>
          <p:nvPr/>
        </p:nvSpPr>
        <p:spPr>
          <a:xfrm>
            <a:off x="6273309" y="459812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游明朝 Light" panose="02020300000000000000" pitchFamily="18" charset="-128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ea typeface="游明朝 Light" panose="020203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82C8B54-1A7A-5558-8AC8-749709873482}"/>
              </a:ext>
            </a:extLst>
          </p:cNvPr>
          <p:cNvSpPr txBox="1"/>
          <p:nvPr/>
        </p:nvSpPr>
        <p:spPr>
          <a:xfrm>
            <a:off x="10704955" y="1581832"/>
            <a:ext cx="1362874" cy="2768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99" dirty="0">
                <a:latin typeface="Arial" panose="020B0604020202020204" pitchFamily="34" charset="0"/>
                <a:cs typeface="Arial" panose="020B0604020202020204" pitchFamily="34" charset="0"/>
              </a:rPr>
              <a:t>error bar : 95%CI</a:t>
            </a:r>
            <a:endParaRPr kumimoji="1" lang="ja-JP" altLang="en-US" sz="11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89701D8-A300-F527-0702-211BCF1FBAD5}"/>
              </a:ext>
            </a:extLst>
          </p:cNvPr>
          <p:cNvSpPr txBox="1"/>
          <p:nvPr/>
        </p:nvSpPr>
        <p:spPr>
          <a:xfrm>
            <a:off x="11091280" y="1365921"/>
            <a:ext cx="976549" cy="2768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199" dirty="0">
                <a:latin typeface="Arial" panose="020B0604020202020204" pitchFamily="34" charset="0"/>
                <a:cs typeface="Arial" panose="020B0604020202020204" pitchFamily="34" charset="0"/>
              </a:rPr>
              <a:t>＊</a:t>
            </a:r>
            <a:r>
              <a:rPr kumimoji="1" lang="en-US" altLang="ja-JP" sz="1199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99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199" dirty="0">
                <a:latin typeface="Arial" panose="020B0604020202020204" pitchFamily="34" charset="0"/>
                <a:cs typeface="Arial" panose="020B0604020202020204" pitchFamily="34" charset="0"/>
              </a:rPr>
              <a:t> &lt; 0.05</a:t>
            </a:r>
            <a:r>
              <a:rPr kumimoji="1" lang="en-US" altLang="ja-JP" sz="1199" dirty="0"/>
              <a:t> </a:t>
            </a:r>
            <a:endParaRPr kumimoji="1" lang="ja-JP" altLang="en-US" sz="11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4CC1E261-F0AA-04F6-0D9C-8CF9E403DF43}"/>
              </a:ext>
            </a:extLst>
          </p:cNvPr>
          <p:cNvGrpSpPr/>
          <p:nvPr/>
        </p:nvGrpSpPr>
        <p:grpSpPr>
          <a:xfrm>
            <a:off x="1007236" y="2052063"/>
            <a:ext cx="181951" cy="45720"/>
            <a:chOff x="18303240" y="1690690"/>
            <a:chExt cx="486410" cy="138905"/>
          </a:xfrm>
        </p:grpSpPr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BE3D8F38-1676-96FD-4E2E-BDE40E48348C}"/>
                </a:ext>
              </a:extLst>
            </p:cNvPr>
            <p:cNvCxnSpPr>
              <a:cxnSpLocks/>
            </p:cNvCxnSpPr>
            <p:nvPr/>
          </p:nvCxnSpPr>
          <p:spPr>
            <a:xfrm>
              <a:off x="18303240" y="1690690"/>
              <a:ext cx="0" cy="1381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C4B4AA2F-2D10-6667-5820-A9F8AB4988F1}"/>
                </a:ext>
              </a:extLst>
            </p:cNvPr>
            <p:cNvCxnSpPr>
              <a:cxnSpLocks/>
            </p:cNvCxnSpPr>
            <p:nvPr/>
          </p:nvCxnSpPr>
          <p:spPr>
            <a:xfrm>
              <a:off x="18303240" y="1690690"/>
              <a:ext cx="4864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id="{41A994B9-3092-95F7-D5FB-143ACCAE78D9}"/>
                </a:ext>
              </a:extLst>
            </p:cNvPr>
            <p:cNvCxnSpPr>
              <a:cxnSpLocks/>
            </p:cNvCxnSpPr>
            <p:nvPr/>
          </p:nvCxnSpPr>
          <p:spPr>
            <a:xfrm>
              <a:off x="18789650" y="1691485"/>
              <a:ext cx="0" cy="1381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075A9DC6-15FF-B77C-1FC0-1DD8546C5260}"/>
              </a:ext>
            </a:extLst>
          </p:cNvPr>
          <p:cNvSpPr txBox="1"/>
          <p:nvPr/>
        </p:nvSpPr>
        <p:spPr>
          <a:xfrm>
            <a:off x="937649" y="1857098"/>
            <a:ext cx="322609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199" dirty="0">
                <a:latin typeface="Arial" panose="020B0604020202020204" pitchFamily="34" charset="0"/>
                <a:cs typeface="Arial" panose="020B0604020202020204" pitchFamily="34" charset="0"/>
              </a:rPr>
              <a:t>＊</a:t>
            </a:r>
          </a:p>
        </p:txBody>
      </p: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23368B79-90FD-0BE2-626E-43E0EFE67424}"/>
              </a:ext>
            </a:extLst>
          </p:cNvPr>
          <p:cNvGrpSpPr/>
          <p:nvPr/>
        </p:nvGrpSpPr>
        <p:grpSpPr>
          <a:xfrm>
            <a:off x="1659508" y="2052063"/>
            <a:ext cx="181951" cy="45720"/>
            <a:chOff x="18303240" y="1690690"/>
            <a:chExt cx="486410" cy="138905"/>
          </a:xfrm>
        </p:grpSpPr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1D096EF5-5737-C6B5-E470-5983AC70F00B}"/>
                </a:ext>
              </a:extLst>
            </p:cNvPr>
            <p:cNvCxnSpPr>
              <a:cxnSpLocks/>
            </p:cNvCxnSpPr>
            <p:nvPr/>
          </p:nvCxnSpPr>
          <p:spPr>
            <a:xfrm>
              <a:off x="18303240" y="1690690"/>
              <a:ext cx="0" cy="1381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73686ECE-902C-5280-E08C-24C1939E4904}"/>
                </a:ext>
              </a:extLst>
            </p:cNvPr>
            <p:cNvCxnSpPr>
              <a:cxnSpLocks/>
            </p:cNvCxnSpPr>
            <p:nvPr/>
          </p:nvCxnSpPr>
          <p:spPr>
            <a:xfrm>
              <a:off x="18303240" y="1690690"/>
              <a:ext cx="4864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EFCD85B7-DD5D-4357-FCBA-A830E8479DA2}"/>
                </a:ext>
              </a:extLst>
            </p:cNvPr>
            <p:cNvCxnSpPr>
              <a:cxnSpLocks/>
            </p:cNvCxnSpPr>
            <p:nvPr/>
          </p:nvCxnSpPr>
          <p:spPr>
            <a:xfrm>
              <a:off x="18789650" y="1691485"/>
              <a:ext cx="0" cy="1381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38" name="グループ化 37">
            <a:extLst>
              <a:ext uri="{FF2B5EF4-FFF2-40B4-BE49-F238E27FC236}">
                <a16:creationId xmlns:a16="http://schemas.microsoft.com/office/drawing/2014/main" id="{200BD875-FB68-601F-47F0-F1E645245683}"/>
              </a:ext>
            </a:extLst>
          </p:cNvPr>
          <p:cNvGrpSpPr/>
          <p:nvPr/>
        </p:nvGrpSpPr>
        <p:grpSpPr>
          <a:xfrm>
            <a:off x="2298610" y="2051801"/>
            <a:ext cx="181951" cy="45720"/>
            <a:chOff x="18303240" y="1690690"/>
            <a:chExt cx="486410" cy="138905"/>
          </a:xfrm>
        </p:grpSpPr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4B90CCD2-421E-7337-B769-D50FE9476B99}"/>
                </a:ext>
              </a:extLst>
            </p:cNvPr>
            <p:cNvCxnSpPr>
              <a:cxnSpLocks/>
            </p:cNvCxnSpPr>
            <p:nvPr/>
          </p:nvCxnSpPr>
          <p:spPr>
            <a:xfrm>
              <a:off x="18303240" y="1690690"/>
              <a:ext cx="0" cy="1381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7F74AD8F-1687-38DB-E78A-FCF0EB85D963}"/>
                </a:ext>
              </a:extLst>
            </p:cNvPr>
            <p:cNvCxnSpPr>
              <a:cxnSpLocks/>
            </p:cNvCxnSpPr>
            <p:nvPr/>
          </p:nvCxnSpPr>
          <p:spPr>
            <a:xfrm>
              <a:off x="18303240" y="1690690"/>
              <a:ext cx="4864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698C6CC8-0A03-3116-0463-599FC7E02A9A}"/>
                </a:ext>
              </a:extLst>
            </p:cNvPr>
            <p:cNvCxnSpPr>
              <a:cxnSpLocks/>
            </p:cNvCxnSpPr>
            <p:nvPr/>
          </p:nvCxnSpPr>
          <p:spPr>
            <a:xfrm>
              <a:off x="18789650" y="1691485"/>
              <a:ext cx="0" cy="1381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2" name="グループ化 41">
            <a:extLst>
              <a:ext uri="{FF2B5EF4-FFF2-40B4-BE49-F238E27FC236}">
                <a16:creationId xmlns:a16="http://schemas.microsoft.com/office/drawing/2014/main" id="{71DD8BC4-FD23-D805-4C77-8020E31D64CA}"/>
              </a:ext>
            </a:extLst>
          </p:cNvPr>
          <p:cNvGrpSpPr/>
          <p:nvPr/>
        </p:nvGrpSpPr>
        <p:grpSpPr>
          <a:xfrm>
            <a:off x="2942264" y="2052063"/>
            <a:ext cx="181951" cy="45720"/>
            <a:chOff x="18303240" y="1690690"/>
            <a:chExt cx="486410" cy="138905"/>
          </a:xfrm>
        </p:grpSpPr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1D4489A1-07B5-4F21-5118-C6968BB09338}"/>
                </a:ext>
              </a:extLst>
            </p:cNvPr>
            <p:cNvCxnSpPr>
              <a:cxnSpLocks/>
            </p:cNvCxnSpPr>
            <p:nvPr/>
          </p:nvCxnSpPr>
          <p:spPr>
            <a:xfrm>
              <a:off x="18303240" y="1690690"/>
              <a:ext cx="0" cy="1381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1FE9843D-7EE0-BF1E-14BF-3F6CF6E6266E}"/>
                </a:ext>
              </a:extLst>
            </p:cNvPr>
            <p:cNvCxnSpPr>
              <a:cxnSpLocks/>
            </p:cNvCxnSpPr>
            <p:nvPr/>
          </p:nvCxnSpPr>
          <p:spPr>
            <a:xfrm>
              <a:off x="18303240" y="1690690"/>
              <a:ext cx="4864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07E83CF5-CCAA-9EB1-70E4-B8EB684F3DE2}"/>
                </a:ext>
              </a:extLst>
            </p:cNvPr>
            <p:cNvCxnSpPr>
              <a:cxnSpLocks/>
            </p:cNvCxnSpPr>
            <p:nvPr/>
          </p:nvCxnSpPr>
          <p:spPr>
            <a:xfrm>
              <a:off x="18789650" y="1691485"/>
              <a:ext cx="0" cy="1381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6" name="グループ化 45">
            <a:extLst>
              <a:ext uri="{FF2B5EF4-FFF2-40B4-BE49-F238E27FC236}">
                <a16:creationId xmlns:a16="http://schemas.microsoft.com/office/drawing/2014/main" id="{C35350C1-3AFC-217E-52C9-1409AB024B23}"/>
              </a:ext>
            </a:extLst>
          </p:cNvPr>
          <p:cNvGrpSpPr/>
          <p:nvPr/>
        </p:nvGrpSpPr>
        <p:grpSpPr>
          <a:xfrm>
            <a:off x="3587466" y="2052063"/>
            <a:ext cx="181951" cy="45720"/>
            <a:chOff x="18303240" y="1690690"/>
            <a:chExt cx="486410" cy="138905"/>
          </a:xfrm>
        </p:grpSpPr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5FC2EA91-82BB-B0E4-077B-736342A25119}"/>
                </a:ext>
              </a:extLst>
            </p:cNvPr>
            <p:cNvCxnSpPr>
              <a:cxnSpLocks/>
            </p:cNvCxnSpPr>
            <p:nvPr/>
          </p:nvCxnSpPr>
          <p:spPr>
            <a:xfrm>
              <a:off x="18303240" y="1690690"/>
              <a:ext cx="0" cy="1381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5782C6E4-92AD-804D-A8C9-8EF1837EC81A}"/>
                </a:ext>
              </a:extLst>
            </p:cNvPr>
            <p:cNvCxnSpPr>
              <a:cxnSpLocks/>
            </p:cNvCxnSpPr>
            <p:nvPr/>
          </p:nvCxnSpPr>
          <p:spPr>
            <a:xfrm>
              <a:off x="18303240" y="1690690"/>
              <a:ext cx="4864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直線コネクタ 48">
              <a:extLst>
                <a:ext uri="{FF2B5EF4-FFF2-40B4-BE49-F238E27FC236}">
                  <a16:creationId xmlns:a16="http://schemas.microsoft.com/office/drawing/2014/main" id="{40ABA8B1-DB49-25EF-5D8E-2BA076D20FD2}"/>
                </a:ext>
              </a:extLst>
            </p:cNvPr>
            <p:cNvCxnSpPr>
              <a:cxnSpLocks/>
            </p:cNvCxnSpPr>
            <p:nvPr/>
          </p:nvCxnSpPr>
          <p:spPr>
            <a:xfrm>
              <a:off x="18789650" y="1691485"/>
              <a:ext cx="0" cy="1381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0" name="グループ化 49">
            <a:extLst>
              <a:ext uri="{FF2B5EF4-FFF2-40B4-BE49-F238E27FC236}">
                <a16:creationId xmlns:a16="http://schemas.microsoft.com/office/drawing/2014/main" id="{707EC8AA-8174-596B-5D5F-E3A1F3A79906}"/>
              </a:ext>
            </a:extLst>
          </p:cNvPr>
          <p:cNvGrpSpPr/>
          <p:nvPr/>
        </p:nvGrpSpPr>
        <p:grpSpPr>
          <a:xfrm>
            <a:off x="4238764" y="2052063"/>
            <a:ext cx="181951" cy="45720"/>
            <a:chOff x="18303240" y="1690690"/>
            <a:chExt cx="486410" cy="138905"/>
          </a:xfrm>
        </p:grpSpPr>
        <p:cxnSp>
          <p:nvCxnSpPr>
            <p:cNvPr id="51" name="直線コネクタ 50">
              <a:extLst>
                <a:ext uri="{FF2B5EF4-FFF2-40B4-BE49-F238E27FC236}">
                  <a16:creationId xmlns:a16="http://schemas.microsoft.com/office/drawing/2014/main" id="{00E37568-ACD5-DAE5-F4A8-D262EE217A36}"/>
                </a:ext>
              </a:extLst>
            </p:cNvPr>
            <p:cNvCxnSpPr>
              <a:cxnSpLocks/>
            </p:cNvCxnSpPr>
            <p:nvPr/>
          </p:nvCxnSpPr>
          <p:spPr>
            <a:xfrm>
              <a:off x="18303240" y="1690690"/>
              <a:ext cx="0" cy="1381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A66605A3-D58B-7FD8-0988-DAD5C25C3B61}"/>
                </a:ext>
              </a:extLst>
            </p:cNvPr>
            <p:cNvCxnSpPr>
              <a:cxnSpLocks/>
            </p:cNvCxnSpPr>
            <p:nvPr/>
          </p:nvCxnSpPr>
          <p:spPr>
            <a:xfrm>
              <a:off x="18303240" y="1690690"/>
              <a:ext cx="4864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E59653A3-E7B5-DFFE-CDFD-25E56771866B}"/>
                </a:ext>
              </a:extLst>
            </p:cNvPr>
            <p:cNvCxnSpPr>
              <a:cxnSpLocks/>
            </p:cNvCxnSpPr>
            <p:nvPr/>
          </p:nvCxnSpPr>
          <p:spPr>
            <a:xfrm>
              <a:off x="18789650" y="1691485"/>
              <a:ext cx="0" cy="1381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4" name="グループ化 53">
            <a:extLst>
              <a:ext uri="{FF2B5EF4-FFF2-40B4-BE49-F238E27FC236}">
                <a16:creationId xmlns:a16="http://schemas.microsoft.com/office/drawing/2014/main" id="{DDA6A3D2-3839-EAD0-4A5F-9D9C253E4D44}"/>
              </a:ext>
            </a:extLst>
          </p:cNvPr>
          <p:cNvGrpSpPr/>
          <p:nvPr/>
        </p:nvGrpSpPr>
        <p:grpSpPr>
          <a:xfrm>
            <a:off x="4883964" y="2051801"/>
            <a:ext cx="181951" cy="45720"/>
            <a:chOff x="18303240" y="1690690"/>
            <a:chExt cx="486410" cy="138905"/>
          </a:xfrm>
        </p:grpSpPr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C2CB2B86-D98C-1030-F113-B3C8EBF45752}"/>
                </a:ext>
              </a:extLst>
            </p:cNvPr>
            <p:cNvCxnSpPr>
              <a:cxnSpLocks/>
            </p:cNvCxnSpPr>
            <p:nvPr/>
          </p:nvCxnSpPr>
          <p:spPr>
            <a:xfrm>
              <a:off x="18303240" y="1690690"/>
              <a:ext cx="0" cy="1381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6" name="直線コネクタ 55">
              <a:extLst>
                <a:ext uri="{FF2B5EF4-FFF2-40B4-BE49-F238E27FC236}">
                  <a16:creationId xmlns:a16="http://schemas.microsoft.com/office/drawing/2014/main" id="{F0D14E96-BA66-8EF8-F858-6445E6FAE45E}"/>
                </a:ext>
              </a:extLst>
            </p:cNvPr>
            <p:cNvCxnSpPr>
              <a:cxnSpLocks/>
            </p:cNvCxnSpPr>
            <p:nvPr/>
          </p:nvCxnSpPr>
          <p:spPr>
            <a:xfrm>
              <a:off x="18303240" y="1690690"/>
              <a:ext cx="4864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7" name="直線コネクタ 56">
              <a:extLst>
                <a:ext uri="{FF2B5EF4-FFF2-40B4-BE49-F238E27FC236}">
                  <a16:creationId xmlns:a16="http://schemas.microsoft.com/office/drawing/2014/main" id="{716DA46E-2543-4BE2-7C05-882289FE7106}"/>
                </a:ext>
              </a:extLst>
            </p:cNvPr>
            <p:cNvCxnSpPr>
              <a:cxnSpLocks/>
            </p:cNvCxnSpPr>
            <p:nvPr/>
          </p:nvCxnSpPr>
          <p:spPr>
            <a:xfrm>
              <a:off x="18789650" y="1691485"/>
              <a:ext cx="0" cy="1381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58" name="グループ化 57">
            <a:extLst>
              <a:ext uri="{FF2B5EF4-FFF2-40B4-BE49-F238E27FC236}">
                <a16:creationId xmlns:a16="http://schemas.microsoft.com/office/drawing/2014/main" id="{948833E0-F835-D867-50DC-B81EA124D729}"/>
              </a:ext>
            </a:extLst>
          </p:cNvPr>
          <p:cNvGrpSpPr/>
          <p:nvPr/>
        </p:nvGrpSpPr>
        <p:grpSpPr>
          <a:xfrm>
            <a:off x="5527615" y="2051801"/>
            <a:ext cx="181951" cy="45720"/>
            <a:chOff x="18303240" y="1690690"/>
            <a:chExt cx="486410" cy="138905"/>
          </a:xfrm>
        </p:grpSpPr>
        <p:cxnSp>
          <p:nvCxnSpPr>
            <p:cNvPr id="59" name="直線コネクタ 58">
              <a:extLst>
                <a:ext uri="{FF2B5EF4-FFF2-40B4-BE49-F238E27FC236}">
                  <a16:creationId xmlns:a16="http://schemas.microsoft.com/office/drawing/2014/main" id="{0610D52D-94A7-A1E9-7C27-5DCEEBC24150}"/>
                </a:ext>
              </a:extLst>
            </p:cNvPr>
            <p:cNvCxnSpPr>
              <a:cxnSpLocks/>
            </p:cNvCxnSpPr>
            <p:nvPr/>
          </p:nvCxnSpPr>
          <p:spPr>
            <a:xfrm>
              <a:off x="18303240" y="1690690"/>
              <a:ext cx="0" cy="1381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0" name="直線コネクタ 59">
              <a:extLst>
                <a:ext uri="{FF2B5EF4-FFF2-40B4-BE49-F238E27FC236}">
                  <a16:creationId xmlns:a16="http://schemas.microsoft.com/office/drawing/2014/main" id="{66566378-D9B2-612A-2917-1DDF7C8D15DC}"/>
                </a:ext>
              </a:extLst>
            </p:cNvPr>
            <p:cNvCxnSpPr>
              <a:cxnSpLocks/>
            </p:cNvCxnSpPr>
            <p:nvPr/>
          </p:nvCxnSpPr>
          <p:spPr>
            <a:xfrm>
              <a:off x="18303240" y="1690690"/>
              <a:ext cx="48641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1" name="直線コネクタ 60">
              <a:extLst>
                <a:ext uri="{FF2B5EF4-FFF2-40B4-BE49-F238E27FC236}">
                  <a16:creationId xmlns:a16="http://schemas.microsoft.com/office/drawing/2014/main" id="{2593F6FE-1A5E-8F77-9A9F-47FF8E5B865D}"/>
                </a:ext>
              </a:extLst>
            </p:cNvPr>
            <p:cNvCxnSpPr>
              <a:cxnSpLocks/>
            </p:cNvCxnSpPr>
            <p:nvPr/>
          </p:nvCxnSpPr>
          <p:spPr>
            <a:xfrm>
              <a:off x="18789650" y="1691485"/>
              <a:ext cx="0" cy="13811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4670054C-8869-7EE2-583A-409D616724DC}"/>
              </a:ext>
            </a:extLst>
          </p:cNvPr>
          <p:cNvSpPr txBox="1"/>
          <p:nvPr/>
        </p:nvSpPr>
        <p:spPr>
          <a:xfrm>
            <a:off x="1589673" y="1857098"/>
            <a:ext cx="322609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199" dirty="0">
                <a:latin typeface="Arial" panose="020B0604020202020204" pitchFamily="34" charset="0"/>
                <a:cs typeface="Arial" panose="020B0604020202020204" pitchFamily="34" charset="0"/>
              </a:rPr>
              <a:t>＊</a:t>
            </a: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1E78F21E-92EB-44A0-9112-6628A7FE11DF}"/>
              </a:ext>
            </a:extLst>
          </p:cNvPr>
          <p:cNvSpPr txBox="1"/>
          <p:nvPr/>
        </p:nvSpPr>
        <p:spPr>
          <a:xfrm>
            <a:off x="2223409" y="1857098"/>
            <a:ext cx="322609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199" dirty="0">
                <a:latin typeface="Arial" panose="020B0604020202020204" pitchFamily="34" charset="0"/>
                <a:cs typeface="Arial" panose="020B0604020202020204" pitchFamily="34" charset="0"/>
              </a:rPr>
              <a:t>＊</a:t>
            </a: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8DEC5CDE-759D-40D3-0359-25E7F4221797}"/>
              </a:ext>
            </a:extLst>
          </p:cNvPr>
          <p:cNvSpPr txBox="1"/>
          <p:nvPr/>
        </p:nvSpPr>
        <p:spPr>
          <a:xfrm>
            <a:off x="2870620" y="1857096"/>
            <a:ext cx="322609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199" dirty="0">
                <a:latin typeface="Arial" panose="020B0604020202020204" pitchFamily="34" charset="0"/>
                <a:cs typeface="Arial" panose="020B0604020202020204" pitchFamily="34" charset="0"/>
              </a:rPr>
              <a:t>＊</a:t>
            </a: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33D8B978-9316-9920-3EE9-08DF2C9840E1}"/>
              </a:ext>
            </a:extLst>
          </p:cNvPr>
          <p:cNvSpPr txBox="1"/>
          <p:nvPr/>
        </p:nvSpPr>
        <p:spPr>
          <a:xfrm>
            <a:off x="3504460" y="1857095"/>
            <a:ext cx="322609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199" dirty="0">
                <a:latin typeface="Arial" panose="020B0604020202020204" pitchFamily="34" charset="0"/>
                <a:cs typeface="Arial" panose="020B0604020202020204" pitchFamily="34" charset="0"/>
              </a:rPr>
              <a:t>＊</a:t>
            </a: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6E4B205F-785A-C94D-3CAA-7DD2D166430F}"/>
              </a:ext>
            </a:extLst>
          </p:cNvPr>
          <p:cNvSpPr txBox="1"/>
          <p:nvPr/>
        </p:nvSpPr>
        <p:spPr>
          <a:xfrm>
            <a:off x="4169385" y="1857095"/>
            <a:ext cx="322609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199" dirty="0">
                <a:latin typeface="Arial" panose="020B0604020202020204" pitchFamily="34" charset="0"/>
                <a:cs typeface="Arial" panose="020B0604020202020204" pitchFamily="34" charset="0"/>
              </a:rPr>
              <a:t>＊</a:t>
            </a: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B7134ACD-996A-F38E-628C-5B3346F8F17F}"/>
              </a:ext>
            </a:extLst>
          </p:cNvPr>
          <p:cNvSpPr txBox="1"/>
          <p:nvPr/>
        </p:nvSpPr>
        <p:spPr>
          <a:xfrm>
            <a:off x="4806940" y="1857095"/>
            <a:ext cx="322609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199" dirty="0">
                <a:latin typeface="Arial" panose="020B0604020202020204" pitchFamily="34" charset="0"/>
                <a:cs typeface="Arial" panose="020B0604020202020204" pitchFamily="34" charset="0"/>
              </a:rPr>
              <a:t>＊</a:t>
            </a: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A728DA7D-2C0D-0688-CBBD-BD1C38A04E91}"/>
              </a:ext>
            </a:extLst>
          </p:cNvPr>
          <p:cNvSpPr txBox="1"/>
          <p:nvPr/>
        </p:nvSpPr>
        <p:spPr>
          <a:xfrm>
            <a:off x="5453810" y="1857093"/>
            <a:ext cx="322609" cy="2768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199" dirty="0">
                <a:latin typeface="Arial" panose="020B0604020202020204" pitchFamily="34" charset="0"/>
                <a:cs typeface="Arial" panose="020B0604020202020204" pitchFamily="34" charset="0"/>
              </a:rPr>
              <a:t>＊</a:t>
            </a:r>
          </a:p>
        </p:txBody>
      </p:sp>
    </p:spTree>
    <p:extLst>
      <p:ext uri="{BB962C8B-B14F-4D97-AF65-F5344CB8AC3E}">
        <p14:creationId xmlns:p14="http://schemas.microsoft.com/office/powerpoint/2010/main" val="20969690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162</TotalTime>
  <Words>26</Words>
  <Application>Microsoft Office PowerPoint</Application>
  <PresentationFormat>ワイド画面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om</dc:creator>
  <cp:lastModifiedBy>nom</cp:lastModifiedBy>
  <cp:revision>255</cp:revision>
  <dcterms:created xsi:type="dcterms:W3CDTF">2024-11-08T11:13:37Z</dcterms:created>
  <dcterms:modified xsi:type="dcterms:W3CDTF">2024-11-24T12:20:45Z</dcterms:modified>
</cp:coreProperties>
</file>